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8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CE903-7C9D-BF4F-ADA8-85AE27341B43}" type="datetimeFigureOut">
              <a:rPr lang="en-US" smtClean="0"/>
              <a:t>11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325DC-A579-8F43-8F12-B20EFD5A9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771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CE903-7C9D-BF4F-ADA8-85AE27341B43}" type="datetimeFigureOut">
              <a:rPr lang="en-US" smtClean="0"/>
              <a:t>11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325DC-A579-8F43-8F12-B20EFD5A9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351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CE903-7C9D-BF4F-ADA8-85AE27341B43}" type="datetimeFigureOut">
              <a:rPr lang="en-US" smtClean="0"/>
              <a:t>11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325DC-A579-8F43-8F12-B20EFD5A9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197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CE903-7C9D-BF4F-ADA8-85AE27341B43}" type="datetimeFigureOut">
              <a:rPr lang="en-US" smtClean="0"/>
              <a:t>11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325DC-A579-8F43-8F12-B20EFD5A9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466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CE903-7C9D-BF4F-ADA8-85AE27341B43}" type="datetimeFigureOut">
              <a:rPr lang="en-US" smtClean="0"/>
              <a:t>11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325DC-A579-8F43-8F12-B20EFD5A9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719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CE903-7C9D-BF4F-ADA8-85AE27341B43}" type="datetimeFigureOut">
              <a:rPr lang="en-US" smtClean="0"/>
              <a:t>11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325DC-A579-8F43-8F12-B20EFD5A9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184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CE903-7C9D-BF4F-ADA8-85AE27341B43}" type="datetimeFigureOut">
              <a:rPr lang="en-US" smtClean="0"/>
              <a:t>11/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325DC-A579-8F43-8F12-B20EFD5A9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8463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CE903-7C9D-BF4F-ADA8-85AE27341B43}" type="datetimeFigureOut">
              <a:rPr lang="en-US" smtClean="0"/>
              <a:t>11/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325DC-A579-8F43-8F12-B20EFD5A9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90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CE903-7C9D-BF4F-ADA8-85AE27341B43}" type="datetimeFigureOut">
              <a:rPr lang="en-US" smtClean="0"/>
              <a:t>11/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325DC-A579-8F43-8F12-B20EFD5A9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4913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CE903-7C9D-BF4F-ADA8-85AE27341B43}" type="datetimeFigureOut">
              <a:rPr lang="en-US" smtClean="0"/>
              <a:t>11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325DC-A579-8F43-8F12-B20EFD5A9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588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CE903-7C9D-BF4F-ADA8-85AE27341B43}" type="datetimeFigureOut">
              <a:rPr lang="en-US" smtClean="0"/>
              <a:t>11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325DC-A579-8F43-8F12-B20EFD5A9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474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2CE903-7C9D-BF4F-ADA8-85AE27341B43}" type="datetimeFigureOut">
              <a:rPr lang="en-US" smtClean="0"/>
              <a:t>11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E325DC-A579-8F43-8F12-B20EFD5A9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075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IPA_TopDiseases_Functions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60199"/>
            <a:ext cx="9144000" cy="317177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-42335" y="390867"/>
            <a:ext cx="6948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lementary Table 5. Ingenuity Pathway </a:t>
            </a:r>
            <a:r>
              <a:rPr lang="en-US" sz="1200" b="1" dirty="0" smtClean="0">
                <a:latin typeface="Times New Roman"/>
                <a:cs typeface="Times New Roman"/>
              </a:rPr>
              <a:t>Analysis results for binary discretization correlated gene list</a:t>
            </a:r>
            <a:endParaRPr lang="en-US" sz="1200" b="1" dirty="0" smtClean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6926672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4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rald Gooden</dc:creator>
  <cp:lastModifiedBy>Gerald Gooden</cp:lastModifiedBy>
  <cp:revision>4</cp:revision>
  <dcterms:created xsi:type="dcterms:W3CDTF">2015-11-05T18:31:20Z</dcterms:created>
  <dcterms:modified xsi:type="dcterms:W3CDTF">2015-11-09T18:25:54Z</dcterms:modified>
</cp:coreProperties>
</file>